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20" r:id="rId1"/>
  </p:sldMasterIdLst>
  <p:notesMasterIdLst>
    <p:notesMasterId r:id="rId6"/>
  </p:notesMasterIdLst>
  <p:sldIdLst>
    <p:sldId id="285" r:id="rId2"/>
    <p:sldId id="284" r:id="rId3"/>
    <p:sldId id="283" r:id="rId4"/>
    <p:sldId id="282" r:id="rId5"/>
  </p:sldIdLst>
  <p:sldSz cx="18000663" cy="122396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BC48EA07-9E4C-4991-3ECD-9E630E2F9641}" name="Geena Paramel" initials="GP" userId="S::geena.paramel@oru.se::b9e31ecf-fc79-4cbd-8de2-e2f24eb3904b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599" autoAdjust="0"/>
    <p:restoredTop sz="95775"/>
  </p:normalViewPr>
  <p:slideViewPr>
    <p:cSldViewPr snapToGrid="0" snapToObjects="1">
      <p:cViewPr varScale="1">
        <p:scale>
          <a:sx n="57" d="100"/>
          <a:sy n="57" d="100"/>
        </p:scale>
        <p:origin x="78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8/10/relationships/authors" Target="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32BA703-A402-415F-8A47-4EE46A604B60}" type="datetimeFigureOut">
              <a:rPr lang="sv-SE" smtClean="0"/>
              <a:t>2024-03-16</a:t>
            </a:fld>
            <a:endParaRPr lang="sv-S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60463" y="1143000"/>
            <a:ext cx="45370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v-S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D682F53-47F7-4F33-8366-918A665E17F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157935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003106"/>
            <a:ext cx="15300564" cy="4261203"/>
          </a:xfrm>
        </p:spPr>
        <p:txBody>
          <a:bodyPr anchor="b"/>
          <a:lstStyle>
            <a:lvl1pPr algn="ctr">
              <a:defRPr sz="1070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6428637"/>
            <a:ext cx="13500497" cy="2955075"/>
          </a:xfrm>
        </p:spPr>
        <p:txBody>
          <a:bodyPr/>
          <a:lstStyle>
            <a:lvl1pPr marL="0" indent="0" algn="ctr">
              <a:buNone/>
              <a:defRPr sz="4283"/>
            </a:lvl1pPr>
            <a:lvl2pPr marL="815965" indent="0" algn="ctr">
              <a:buNone/>
              <a:defRPr sz="3569"/>
            </a:lvl2pPr>
            <a:lvl3pPr marL="1631930" indent="0" algn="ctr">
              <a:buNone/>
              <a:defRPr sz="3212"/>
            </a:lvl3pPr>
            <a:lvl4pPr marL="2447895" indent="0" algn="ctr">
              <a:buNone/>
              <a:defRPr sz="2856"/>
            </a:lvl4pPr>
            <a:lvl5pPr marL="3263859" indent="0" algn="ctr">
              <a:buNone/>
              <a:defRPr sz="2856"/>
            </a:lvl5pPr>
            <a:lvl6pPr marL="4079824" indent="0" algn="ctr">
              <a:buNone/>
              <a:defRPr sz="2856"/>
            </a:lvl6pPr>
            <a:lvl7pPr marL="4895789" indent="0" algn="ctr">
              <a:buNone/>
              <a:defRPr sz="2856"/>
            </a:lvl7pPr>
            <a:lvl8pPr marL="5711754" indent="0" algn="ctr">
              <a:buNone/>
              <a:defRPr sz="2856"/>
            </a:lvl8pPr>
            <a:lvl9pPr marL="6527719" indent="0" algn="ctr">
              <a:buNone/>
              <a:defRPr sz="2856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B8ADC-DA5B-9447-8E05-978D31DDCE6F}" type="datetimeFigureOut">
              <a:rPr lang="x-none" smtClean="0"/>
              <a:t>16-03-2024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D46C-0824-774F-B2D6-E98F597CF41D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8446478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B8ADC-DA5B-9447-8E05-978D31DDCE6F}" type="datetimeFigureOut">
              <a:rPr lang="x-none" smtClean="0"/>
              <a:t>16-03-2024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D46C-0824-774F-B2D6-E98F597CF41D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4123548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651647"/>
            <a:ext cx="3881393" cy="1037251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651647"/>
            <a:ext cx="11419171" cy="1037251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B8ADC-DA5B-9447-8E05-978D31DDCE6F}" type="datetimeFigureOut">
              <a:rPr lang="x-none" smtClean="0"/>
              <a:t>16-03-2024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D46C-0824-774F-B2D6-E98F597CF41D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286362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B8ADC-DA5B-9447-8E05-978D31DDCE6F}" type="datetimeFigureOut">
              <a:rPr lang="x-none" smtClean="0"/>
              <a:t>16-03-2024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D46C-0824-774F-B2D6-E98F597CF41D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7830589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3051410"/>
            <a:ext cx="15525572" cy="5091343"/>
          </a:xfrm>
        </p:spPr>
        <p:txBody>
          <a:bodyPr anchor="b"/>
          <a:lstStyle>
            <a:lvl1pPr>
              <a:defRPr sz="1070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8190919"/>
            <a:ext cx="15525572" cy="2677417"/>
          </a:xfrm>
        </p:spPr>
        <p:txBody>
          <a:bodyPr/>
          <a:lstStyle>
            <a:lvl1pPr marL="0" indent="0">
              <a:buNone/>
              <a:defRPr sz="4283">
                <a:solidFill>
                  <a:schemeClr val="tx1"/>
                </a:solidFill>
              </a:defRPr>
            </a:lvl1pPr>
            <a:lvl2pPr marL="815965" indent="0">
              <a:buNone/>
              <a:defRPr sz="3569">
                <a:solidFill>
                  <a:schemeClr val="tx1">
                    <a:tint val="75000"/>
                  </a:schemeClr>
                </a:solidFill>
              </a:defRPr>
            </a:lvl2pPr>
            <a:lvl3pPr marL="1631930" indent="0">
              <a:buNone/>
              <a:defRPr sz="3212">
                <a:solidFill>
                  <a:schemeClr val="tx1">
                    <a:tint val="75000"/>
                  </a:schemeClr>
                </a:solidFill>
              </a:defRPr>
            </a:lvl3pPr>
            <a:lvl4pPr marL="2447895" indent="0">
              <a:buNone/>
              <a:defRPr sz="2856">
                <a:solidFill>
                  <a:schemeClr val="tx1">
                    <a:tint val="75000"/>
                  </a:schemeClr>
                </a:solidFill>
              </a:defRPr>
            </a:lvl4pPr>
            <a:lvl5pPr marL="3263859" indent="0">
              <a:buNone/>
              <a:defRPr sz="2856">
                <a:solidFill>
                  <a:schemeClr val="tx1">
                    <a:tint val="75000"/>
                  </a:schemeClr>
                </a:solidFill>
              </a:defRPr>
            </a:lvl5pPr>
            <a:lvl6pPr marL="4079824" indent="0">
              <a:buNone/>
              <a:defRPr sz="2856">
                <a:solidFill>
                  <a:schemeClr val="tx1">
                    <a:tint val="75000"/>
                  </a:schemeClr>
                </a:solidFill>
              </a:defRPr>
            </a:lvl6pPr>
            <a:lvl7pPr marL="4895789" indent="0">
              <a:buNone/>
              <a:defRPr sz="2856">
                <a:solidFill>
                  <a:schemeClr val="tx1">
                    <a:tint val="75000"/>
                  </a:schemeClr>
                </a:solidFill>
              </a:defRPr>
            </a:lvl7pPr>
            <a:lvl8pPr marL="5711754" indent="0">
              <a:buNone/>
              <a:defRPr sz="2856">
                <a:solidFill>
                  <a:schemeClr val="tx1">
                    <a:tint val="75000"/>
                  </a:schemeClr>
                </a:solidFill>
              </a:defRPr>
            </a:lvl8pPr>
            <a:lvl9pPr marL="6527719" indent="0">
              <a:buNone/>
              <a:defRPr sz="285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B8ADC-DA5B-9447-8E05-978D31DDCE6F}" type="datetimeFigureOut">
              <a:rPr lang="x-none" smtClean="0"/>
              <a:t>16-03-2024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D46C-0824-774F-B2D6-E98F597CF41D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8517985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3258233"/>
            <a:ext cx="7650282" cy="776593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3258233"/>
            <a:ext cx="7650282" cy="776593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B8ADC-DA5B-9447-8E05-978D31DDCE6F}" type="datetimeFigureOut">
              <a:rPr lang="x-none" smtClean="0"/>
              <a:t>16-03-2024</a:t>
            </a:fld>
            <a:endParaRPr lang="x-non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D46C-0824-774F-B2D6-E98F597CF41D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0451601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651649"/>
            <a:ext cx="15525572" cy="236576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3000409"/>
            <a:ext cx="7615123" cy="1470454"/>
          </a:xfrm>
        </p:spPr>
        <p:txBody>
          <a:bodyPr anchor="b"/>
          <a:lstStyle>
            <a:lvl1pPr marL="0" indent="0">
              <a:buNone/>
              <a:defRPr sz="4283" b="1"/>
            </a:lvl1pPr>
            <a:lvl2pPr marL="815965" indent="0">
              <a:buNone/>
              <a:defRPr sz="3569" b="1"/>
            </a:lvl2pPr>
            <a:lvl3pPr marL="1631930" indent="0">
              <a:buNone/>
              <a:defRPr sz="3212" b="1"/>
            </a:lvl3pPr>
            <a:lvl4pPr marL="2447895" indent="0">
              <a:buNone/>
              <a:defRPr sz="2856" b="1"/>
            </a:lvl4pPr>
            <a:lvl5pPr marL="3263859" indent="0">
              <a:buNone/>
              <a:defRPr sz="2856" b="1"/>
            </a:lvl5pPr>
            <a:lvl6pPr marL="4079824" indent="0">
              <a:buNone/>
              <a:defRPr sz="2856" b="1"/>
            </a:lvl6pPr>
            <a:lvl7pPr marL="4895789" indent="0">
              <a:buNone/>
              <a:defRPr sz="2856" b="1"/>
            </a:lvl7pPr>
            <a:lvl8pPr marL="5711754" indent="0">
              <a:buNone/>
              <a:defRPr sz="2856" b="1"/>
            </a:lvl8pPr>
            <a:lvl9pPr marL="6527719" indent="0">
              <a:buNone/>
              <a:defRPr sz="285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4470863"/>
            <a:ext cx="7615123" cy="65759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3000409"/>
            <a:ext cx="7652626" cy="1470454"/>
          </a:xfrm>
        </p:spPr>
        <p:txBody>
          <a:bodyPr anchor="b"/>
          <a:lstStyle>
            <a:lvl1pPr marL="0" indent="0">
              <a:buNone/>
              <a:defRPr sz="4283" b="1"/>
            </a:lvl1pPr>
            <a:lvl2pPr marL="815965" indent="0">
              <a:buNone/>
              <a:defRPr sz="3569" b="1"/>
            </a:lvl2pPr>
            <a:lvl3pPr marL="1631930" indent="0">
              <a:buNone/>
              <a:defRPr sz="3212" b="1"/>
            </a:lvl3pPr>
            <a:lvl4pPr marL="2447895" indent="0">
              <a:buNone/>
              <a:defRPr sz="2856" b="1"/>
            </a:lvl4pPr>
            <a:lvl5pPr marL="3263859" indent="0">
              <a:buNone/>
              <a:defRPr sz="2856" b="1"/>
            </a:lvl5pPr>
            <a:lvl6pPr marL="4079824" indent="0">
              <a:buNone/>
              <a:defRPr sz="2856" b="1"/>
            </a:lvl6pPr>
            <a:lvl7pPr marL="4895789" indent="0">
              <a:buNone/>
              <a:defRPr sz="2856" b="1"/>
            </a:lvl7pPr>
            <a:lvl8pPr marL="5711754" indent="0">
              <a:buNone/>
              <a:defRPr sz="2856" b="1"/>
            </a:lvl8pPr>
            <a:lvl9pPr marL="6527719" indent="0">
              <a:buNone/>
              <a:defRPr sz="285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4470863"/>
            <a:ext cx="7652626" cy="65759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B8ADC-DA5B-9447-8E05-978D31DDCE6F}" type="datetimeFigureOut">
              <a:rPr lang="x-none" smtClean="0"/>
              <a:t>16-03-2024</a:t>
            </a:fld>
            <a:endParaRPr lang="x-non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D46C-0824-774F-B2D6-E98F597CF41D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41188168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B8ADC-DA5B-9447-8E05-978D31DDCE6F}" type="datetimeFigureOut">
              <a:rPr lang="x-none" smtClean="0"/>
              <a:t>16-03-2024</a:t>
            </a:fld>
            <a:endParaRPr lang="x-non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D46C-0824-774F-B2D6-E98F597CF41D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2127510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B8ADC-DA5B-9447-8E05-978D31DDCE6F}" type="datetimeFigureOut">
              <a:rPr lang="x-none" smtClean="0"/>
              <a:t>16-03-2024</a:t>
            </a:fld>
            <a:endParaRPr lang="x-non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D46C-0824-774F-B2D6-E98F597CF41D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8773723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815975"/>
            <a:ext cx="5805682" cy="2855913"/>
          </a:xfrm>
        </p:spPr>
        <p:txBody>
          <a:bodyPr anchor="b"/>
          <a:lstStyle>
            <a:lvl1pPr>
              <a:defRPr sz="571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1762282"/>
            <a:ext cx="9112836" cy="8698067"/>
          </a:xfrm>
        </p:spPr>
        <p:txBody>
          <a:bodyPr/>
          <a:lstStyle>
            <a:lvl1pPr>
              <a:defRPr sz="5711"/>
            </a:lvl1pPr>
            <a:lvl2pPr>
              <a:defRPr sz="4997"/>
            </a:lvl2pPr>
            <a:lvl3pPr>
              <a:defRPr sz="4283"/>
            </a:lvl3pPr>
            <a:lvl4pPr>
              <a:defRPr sz="3569"/>
            </a:lvl4pPr>
            <a:lvl5pPr>
              <a:defRPr sz="3569"/>
            </a:lvl5pPr>
            <a:lvl6pPr>
              <a:defRPr sz="3569"/>
            </a:lvl6pPr>
            <a:lvl7pPr>
              <a:defRPr sz="3569"/>
            </a:lvl7pPr>
            <a:lvl8pPr>
              <a:defRPr sz="3569"/>
            </a:lvl8pPr>
            <a:lvl9pPr>
              <a:defRPr sz="356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3671887"/>
            <a:ext cx="5805682" cy="6802626"/>
          </a:xfrm>
        </p:spPr>
        <p:txBody>
          <a:bodyPr/>
          <a:lstStyle>
            <a:lvl1pPr marL="0" indent="0">
              <a:buNone/>
              <a:defRPr sz="2856"/>
            </a:lvl1pPr>
            <a:lvl2pPr marL="815965" indent="0">
              <a:buNone/>
              <a:defRPr sz="2499"/>
            </a:lvl2pPr>
            <a:lvl3pPr marL="1631930" indent="0">
              <a:buNone/>
              <a:defRPr sz="2142"/>
            </a:lvl3pPr>
            <a:lvl4pPr marL="2447895" indent="0">
              <a:buNone/>
              <a:defRPr sz="1785"/>
            </a:lvl4pPr>
            <a:lvl5pPr marL="3263859" indent="0">
              <a:buNone/>
              <a:defRPr sz="1785"/>
            </a:lvl5pPr>
            <a:lvl6pPr marL="4079824" indent="0">
              <a:buNone/>
              <a:defRPr sz="1785"/>
            </a:lvl6pPr>
            <a:lvl7pPr marL="4895789" indent="0">
              <a:buNone/>
              <a:defRPr sz="1785"/>
            </a:lvl7pPr>
            <a:lvl8pPr marL="5711754" indent="0">
              <a:buNone/>
              <a:defRPr sz="1785"/>
            </a:lvl8pPr>
            <a:lvl9pPr marL="6527719" indent="0">
              <a:buNone/>
              <a:defRPr sz="178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B8ADC-DA5B-9447-8E05-978D31DDCE6F}" type="datetimeFigureOut">
              <a:rPr lang="x-none" smtClean="0"/>
              <a:t>16-03-2024</a:t>
            </a:fld>
            <a:endParaRPr lang="x-non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D46C-0824-774F-B2D6-E98F597CF41D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2904501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815975"/>
            <a:ext cx="5805682" cy="2855913"/>
          </a:xfrm>
        </p:spPr>
        <p:txBody>
          <a:bodyPr anchor="b"/>
          <a:lstStyle>
            <a:lvl1pPr>
              <a:defRPr sz="571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1762282"/>
            <a:ext cx="9112836" cy="8698067"/>
          </a:xfrm>
        </p:spPr>
        <p:txBody>
          <a:bodyPr anchor="t"/>
          <a:lstStyle>
            <a:lvl1pPr marL="0" indent="0">
              <a:buNone/>
              <a:defRPr sz="5711"/>
            </a:lvl1pPr>
            <a:lvl2pPr marL="815965" indent="0">
              <a:buNone/>
              <a:defRPr sz="4997"/>
            </a:lvl2pPr>
            <a:lvl3pPr marL="1631930" indent="0">
              <a:buNone/>
              <a:defRPr sz="4283"/>
            </a:lvl3pPr>
            <a:lvl4pPr marL="2447895" indent="0">
              <a:buNone/>
              <a:defRPr sz="3569"/>
            </a:lvl4pPr>
            <a:lvl5pPr marL="3263859" indent="0">
              <a:buNone/>
              <a:defRPr sz="3569"/>
            </a:lvl5pPr>
            <a:lvl6pPr marL="4079824" indent="0">
              <a:buNone/>
              <a:defRPr sz="3569"/>
            </a:lvl6pPr>
            <a:lvl7pPr marL="4895789" indent="0">
              <a:buNone/>
              <a:defRPr sz="3569"/>
            </a:lvl7pPr>
            <a:lvl8pPr marL="5711754" indent="0">
              <a:buNone/>
              <a:defRPr sz="3569"/>
            </a:lvl8pPr>
            <a:lvl9pPr marL="6527719" indent="0">
              <a:buNone/>
              <a:defRPr sz="356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3671887"/>
            <a:ext cx="5805682" cy="6802626"/>
          </a:xfrm>
        </p:spPr>
        <p:txBody>
          <a:bodyPr/>
          <a:lstStyle>
            <a:lvl1pPr marL="0" indent="0">
              <a:buNone/>
              <a:defRPr sz="2856"/>
            </a:lvl1pPr>
            <a:lvl2pPr marL="815965" indent="0">
              <a:buNone/>
              <a:defRPr sz="2499"/>
            </a:lvl2pPr>
            <a:lvl3pPr marL="1631930" indent="0">
              <a:buNone/>
              <a:defRPr sz="2142"/>
            </a:lvl3pPr>
            <a:lvl4pPr marL="2447895" indent="0">
              <a:buNone/>
              <a:defRPr sz="1785"/>
            </a:lvl4pPr>
            <a:lvl5pPr marL="3263859" indent="0">
              <a:buNone/>
              <a:defRPr sz="1785"/>
            </a:lvl5pPr>
            <a:lvl6pPr marL="4079824" indent="0">
              <a:buNone/>
              <a:defRPr sz="1785"/>
            </a:lvl6pPr>
            <a:lvl7pPr marL="4895789" indent="0">
              <a:buNone/>
              <a:defRPr sz="1785"/>
            </a:lvl7pPr>
            <a:lvl8pPr marL="5711754" indent="0">
              <a:buNone/>
              <a:defRPr sz="1785"/>
            </a:lvl8pPr>
            <a:lvl9pPr marL="6527719" indent="0">
              <a:buNone/>
              <a:defRPr sz="178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BB8ADC-DA5B-9447-8E05-978D31DDCE6F}" type="datetimeFigureOut">
              <a:rPr lang="x-none" smtClean="0"/>
              <a:t>16-03-2024</a:t>
            </a:fld>
            <a:endParaRPr lang="x-non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4D46C-0824-774F-B2D6-E98F597CF41D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3801780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651649"/>
            <a:ext cx="15525572" cy="23657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3258233"/>
            <a:ext cx="15525572" cy="776593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1344322"/>
            <a:ext cx="4050149" cy="6516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4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BB8ADC-DA5B-9447-8E05-978D31DDCE6F}" type="datetimeFigureOut">
              <a:rPr lang="x-none" smtClean="0"/>
              <a:t>16-03-2024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1344322"/>
            <a:ext cx="6075224" cy="6516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4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1344322"/>
            <a:ext cx="4050149" cy="6516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4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54D46C-0824-774F-B2D6-E98F597CF41D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25097174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1631930" rtl="0" eaLnBrk="1" latinLnBrk="0" hangingPunct="1">
        <a:lnSpc>
          <a:spcPct val="90000"/>
        </a:lnSpc>
        <a:spcBef>
          <a:spcPct val="0"/>
        </a:spcBef>
        <a:buNone/>
        <a:defRPr sz="785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7982" indent="-407982" algn="l" defTabSz="1631930" rtl="0" eaLnBrk="1" latinLnBrk="0" hangingPunct="1">
        <a:lnSpc>
          <a:spcPct val="90000"/>
        </a:lnSpc>
        <a:spcBef>
          <a:spcPts val="1785"/>
        </a:spcBef>
        <a:buFont typeface="Arial" panose="020B0604020202020204" pitchFamily="34" charset="0"/>
        <a:buChar char="•"/>
        <a:defRPr sz="4997" kern="1200">
          <a:solidFill>
            <a:schemeClr val="tx1"/>
          </a:solidFill>
          <a:latin typeface="+mn-lt"/>
          <a:ea typeface="+mn-ea"/>
          <a:cs typeface="+mn-cs"/>
        </a:defRPr>
      </a:lvl1pPr>
      <a:lvl2pPr marL="1223947" indent="-407982" algn="l" defTabSz="1631930" rtl="0" eaLnBrk="1" latinLnBrk="0" hangingPunct="1">
        <a:lnSpc>
          <a:spcPct val="90000"/>
        </a:lnSpc>
        <a:spcBef>
          <a:spcPts val="892"/>
        </a:spcBef>
        <a:buFont typeface="Arial" panose="020B0604020202020204" pitchFamily="34" charset="0"/>
        <a:buChar char="•"/>
        <a:defRPr sz="4283" kern="1200">
          <a:solidFill>
            <a:schemeClr val="tx1"/>
          </a:solidFill>
          <a:latin typeface="+mn-lt"/>
          <a:ea typeface="+mn-ea"/>
          <a:cs typeface="+mn-cs"/>
        </a:defRPr>
      </a:lvl2pPr>
      <a:lvl3pPr marL="2039912" indent="-407982" algn="l" defTabSz="1631930" rtl="0" eaLnBrk="1" latinLnBrk="0" hangingPunct="1">
        <a:lnSpc>
          <a:spcPct val="90000"/>
        </a:lnSpc>
        <a:spcBef>
          <a:spcPts val="892"/>
        </a:spcBef>
        <a:buFont typeface="Arial" panose="020B0604020202020204" pitchFamily="34" charset="0"/>
        <a:buChar char="•"/>
        <a:defRPr sz="3569" kern="1200">
          <a:solidFill>
            <a:schemeClr val="tx1"/>
          </a:solidFill>
          <a:latin typeface="+mn-lt"/>
          <a:ea typeface="+mn-ea"/>
          <a:cs typeface="+mn-cs"/>
        </a:defRPr>
      </a:lvl3pPr>
      <a:lvl4pPr marL="2855877" indent="-407982" algn="l" defTabSz="1631930" rtl="0" eaLnBrk="1" latinLnBrk="0" hangingPunct="1">
        <a:lnSpc>
          <a:spcPct val="90000"/>
        </a:lnSpc>
        <a:spcBef>
          <a:spcPts val="892"/>
        </a:spcBef>
        <a:buFont typeface="Arial" panose="020B0604020202020204" pitchFamily="34" charset="0"/>
        <a:buChar char="•"/>
        <a:defRPr sz="3212" kern="1200">
          <a:solidFill>
            <a:schemeClr val="tx1"/>
          </a:solidFill>
          <a:latin typeface="+mn-lt"/>
          <a:ea typeface="+mn-ea"/>
          <a:cs typeface="+mn-cs"/>
        </a:defRPr>
      </a:lvl4pPr>
      <a:lvl5pPr marL="3671842" indent="-407982" algn="l" defTabSz="1631930" rtl="0" eaLnBrk="1" latinLnBrk="0" hangingPunct="1">
        <a:lnSpc>
          <a:spcPct val="90000"/>
        </a:lnSpc>
        <a:spcBef>
          <a:spcPts val="892"/>
        </a:spcBef>
        <a:buFont typeface="Arial" panose="020B0604020202020204" pitchFamily="34" charset="0"/>
        <a:buChar char="•"/>
        <a:defRPr sz="3212" kern="1200">
          <a:solidFill>
            <a:schemeClr val="tx1"/>
          </a:solidFill>
          <a:latin typeface="+mn-lt"/>
          <a:ea typeface="+mn-ea"/>
          <a:cs typeface="+mn-cs"/>
        </a:defRPr>
      </a:lvl5pPr>
      <a:lvl6pPr marL="4487807" indent="-407982" algn="l" defTabSz="1631930" rtl="0" eaLnBrk="1" latinLnBrk="0" hangingPunct="1">
        <a:lnSpc>
          <a:spcPct val="90000"/>
        </a:lnSpc>
        <a:spcBef>
          <a:spcPts val="892"/>
        </a:spcBef>
        <a:buFont typeface="Arial" panose="020B0604020202020204" pitchFamily="34" charset="0"/>
        <a:buChar char="•"/>
        <a:defRPr sz="3212" kern="1200">
          <a:solidFill>
            <a:schemeClr val="tx1"/>
          </a:solidFill>
          <a:latin typeface="+mn-lt"/>
          <a:ea typeface="+mn-ea"/>
          <a:cs typeface="+mn-cs"/>
        </a:defRPr>
      </a:lvl6pPr>
      <a:lvl7pPr marL="5303771" indent="-407982" algn="l" defTabSz="1631930" rtl="0" eaLnBrk="1" latinLnBrk="0" hangingPunct="1">
        <a:lnSpc>
          <a:spcPct val="90000"/>
        </a:lnSpc>
        <a:spcBef>
          <a:spcPts val="892"/>
        </a:spcBef>
        <a:buFont typeface="Arial" panose="020B0604020202020204" pitchFamily="34" charset="0"/>
        <a:buChar char="•"/>
        <a:defRPr sz="3212" kern="1200">
          <a:solidFill>
            <a:schemeClr val="tx1"/>
          </a:solidFill>
          <a:latin typeface="+mn-lt"/>
          <a:ea typeface="+mn-ea"/>
          <a:cs typeface="+mn-cs"/>
        </a:defRPr>
      </a:lvl7pPr>
      <a:lvl8pPr marL="6119736" indent="-407982" algn="l" defTabSz="1631930" rtl="0" eaLnBrk="1" latinLnBrk="0" hangingPunct="1">
        <a:lnSpc>
          <a:spcPct val="90000"/>
        </a:lnSpc>
        <a:spcBef>
          <a:spcPts val="892"/>
        </a:spcBef>
        <a:buFont typeface="Arial" panose="020B0604020202020204" pitchFamily="34" charset="0"/>
        <a:buChar char="•"/>
        <a:defRPr sz="3212" kern="1200">
          <a:solidFill>
            <a:schemeClr val="tx1"/>
          </a:solidFill>
          <a:latin typeface="+mn-lt"/>
          <a:ea typeface="+mn-ea"/>
          <a:cs typeface="+mn-cs"/>
        </a:defRPr>
      </a:lvl8pPr>
      <a:lvl9pPr marL="6935701" indent="-407982" algn="l" defTabSz="1631930" rtl="0" eaLnBrk="1" latinLnBrk="0" hangingPunct="1">
        <a:lnSpc>
          <a:spcPct val="90000"/>
        </a:lnSpc>
        <a:spcBef>
          <a:spcPts val="892"/>
        </a:spcBef>
        <a:buFont typeface="Arial" panose="020B0604020202020204" pitchFamily="34" charset="0"/>
        <a:buChar char="•"/>
        <a:defRPr sz="321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31930" rtl="0" eaLnBrk="1" latinLnBrk="0" hangingPunct="1">
        <a:defRPr sz="3212" kern="1200">
          <a:solidFill>
            <a:schemeClr val="tx1"/>
          </a:solidFill>
          <a:latin typeface="+mn-lt"/>
          <a:ea typeface="+mn-ea"/>
          <a:cs typeface="+mn-cs"/>
        </a:defRPr>
      </a:lvl1pPr>
      <a:lvl2pPr marL="815965" algn="l" defTabSz="1631930" rtl="0" eaLnBrk="1" latinLnBrk="0" hangingPunct="1">
        <a:defRPr sz="3212" kern="1200">
          <a:solidFill>
            <a:schemeClr val="tx1"/>
          </a:solidFill>
          <a:latin typeface="+mn-lt"/>
          <a:ea typeface="+mn-ea"/>
          <a:cs typeface="+mn-cs"/>
        </a:defRPr>
      </a:lvl2pPr>
      <a:lvl3pPr marL="1631930" algn="l" defTabSz="1631930" rtl="0" eaLnBrk="1" latinLnBrk="0" hangingPunct="1">
        <a:defRPr sz="3212" kern="1200">
          <a:solidFill>
            <a:schemeClr val="tx1"/>
          </a:solidFill>
          <a:latin typeface="+mn-lt"/>
          <a:ea typeface="+mn-ea"/>
          <a:cs typeface="+mn-cs"/>
        </a:defRPr>
      </a:lvl3pPr>
      <a:lvl4pPr marL="2447895" algn="l" defTabSz="1631930" rtl="0" eaLnBrk="1" latinLnBrk="0" hangingPunct="1">
        <a:defRPr sz="3212" kern="1200">
          <a:solidFill>
            <a:schemeClr val="tx1"/>
          </a:solidFill>
          <a:latin typeface="+mn-lt"/>
          <a:ea typeface="+mn-ea"/>
          <a:cs typeface="+mn-cs"/>
        </a:defRPr>
      </a:lvl4pPr>
      <a:lvl5pPr marL="3263859" algn="l" defTabSz="1631930" rtl="0" eaLnBrk="1" latinLnBrk="0" hangingPunct="1">
        <a:defRPr sz="3212" kern="1200">
          <a:solidFill>
            <a:schemeClr val="tx1"/>
          </a:solidFill>
          <a:latin typeface="+mn-lt"/>
          <a:ea typeface="+mn-ea"/>
          <a:cs typeface="+mn-cs"/>
        </a:defRPr>
      </a:lvl5pPr>
      <a:lvl6pPr marL="4079824" algn="l" defTabSz="1631930" rtl="0" eaLnBrk="1" latinLnBrk="0" hangingPunct="1">
        <a:defRPr sz="3212" kern="1200">
          <a:solidFill>
            <a:schemeClr val="tx1"/>
          </a:solidFill>
          <a:latin typeface="+mn-lt"/>
          <a:ea typeface="+mn-ea"/>
          <a:cs typeface="+mn-cs"/>
        </a:defRPr>
      </a:lvl6pPr>
      <a:lvl7pPr marL="4895789" algn="l" defTabSz="1631930" rtl="0" eaLnBrk="1" latinLnBrk="0" hangingPunct="1">
        <a:defRPr sz="3212" kern="1200">
          <a:solidFill>
            <a:schemeClr val="tx1"/>
          </a:solidFill>
          <a:latin typeface="+mn-lt"/>
          <a:ea typeface="+mn-ea"/>
          <a:cs typeface="+mn-cs"/>
        </a:defRPr>
      </a:lvl7pPr>
      <a:lvl8pPr marL="5711754" algn="l" defTabSz="1631930" rtl="0" eaLnBrk="1" latinLnBrk="0" hangingPunct="1">
        <a:defRPr sz="3212" kern="1200">
          <a:solidFill>
            <a:schemeClr val="tx1"/>
          </a:solidFill>
          <a:latin typeface="+mn-lt"/>
          <a:ea typeface="+mn-ea"/>
          <a:cs typeface="+mn-cs"/>
        </a:defRPr>
      </a:lvl8pPr>
      <a:lvl9pPr marL="6527719" algn="l" defTabSz="1631930" rtl="0" eaLnBrk="1" latinLnBrk="0" hangingPunct="1">
        <a:defRPr sz="321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emf"/><Relationship Id="rId5" Type="http://schemas.openxmlformats.org/officeDocument/2006/relationships/image" Target="../media/image15.emf"/><Relationship Id="rId4" Type="http://schemas.openxmlformats.org/officeDocument/2006/relationships/image" Target="../media/image1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7" Type="http://schemas.openxmlformats.org/officeDocument/2006/relationships/image" Target="../media/image22.emf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emf"/><Relationship Id="rId5" Type="http://schemas.openxmlformats.org/officeDocument/2006/relationships/image" Target="../media/image20.emf"/><Relationship Id="rId4" Type="http://schemas.openxmlformats.org/officeDocument/2006/relationships/image" Target="../media/image1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xmlns="" id="{A2B33DAC-72C9-D90C-3B60-F6FCB30CD15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24580156"/>
              </p:ext>
            </p:extLst>
          </p:nvPr>
        </p:nvGraphicFramePr>
        <p:xfrm>
          <a:off x="5298839" y="1914591"/>
          <a:ext cx="5129212" cy="62451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9" r:id="rId3" imgW="2655641" imgH="3234303" progId="Prism9.Document">
                  <p:embed/>
                </p:oleObj>
              </mc:Choice>
              <mc:Fallback>
                <p:oleObj name="Prism 9" r:id="rId3" imgW="2655641" imgH="323430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298839" y="1914591"/>
                        <a:ext cx="5129212" cy="62451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0C3A4832-53E6-B1FD-B8EC-3739A6983880}"/>
              </a:ext>
            </a:extLst>
          </p:cNvPr>
          <p:cNvSpPr txBox="1"/>
          <p:nvPr/>
        </p:nvSpPr>
        <p:spPr>
          <a:xfrm>
            <a:off x="2292008" y="8510487"/>
            <a:ext cx="13599302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ose dependent cytotoxicity of CC in VSMCs. VSMCs were treated with CC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r 24 hrs. Cytotoxicity of CC on VSMCs was measure by 7AAD staining using flow cytometry. </a:t>
            </a:r>
            <a:r>
              <a:rPr lang="en-US" sz="1000" dirty="0">
                <a:solidFill>
                  <a:srgbClr val="22222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ta are representative of experiments from VSMCs of 4 donors and displayed as mean ± SD.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sv-SE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95892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>
            <a:extLst>
              <a:ext uri="{FF2B5EF4-FFF2-40B4-BE49-F238E27FC236}">
                <a16:creationId xmlns:a16="http://schemas.microsoft.com/office/drawing/2014/main" xmlns="" id="{154C26AB-340A-4660-2F73-BDB049FBA63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-1637" b="15307"/>
          <a:stretch/>
        </p:blipFill>
        <p:spPr>
          <a:xfrm>
            <a:off x="10782139" y="7595642"/>
            <a:ext cx="3143369" cy="3255216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1BFD5BD1-61C0-9095-C3F6-CBBDB2E65399}"/>
              </a:ext>
            </a:extLst>
          </p:cNvPr>
          <p:cNvSpPr txBox="1"/>
          <p:nvPr/>
        </p:nvSpPr>
        <p:spPr>
          <a:xfrm>
            <a:off x="1608614" y="11369458"/>
            <a:ext cx="1359930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low cytometry analysis of CCs uptake in VSMCs. Cells were gated on 7AAD negative population according to granularity on side scatter.</a:t>
            </a:r>
            <a:endParaRPr lang="sv-SE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BBEFC284-186A-0C1F-3DAC-4C45AEB42211}"/>
              </a:ext>
            </a:extLst>
          </p:cNvPr>
          <p:cNvSpPr txBox="1"/>
          <p:nvPr/>
        </p:nvSpPr>
        <p:spPr>
          <a:xfrm>
            <a:off x="0" y="1709588"/>
            <a:ext cx="1918322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sv-SE" sz="2400" b="1" dirty="0" err="1"/>
              <a:t>Untreated</a:t>
            </a:r>
            <a:r>
              <a:rPr lang="sv-SE" sz="2400" b="1" dirty="0"/>
              <a:t> </a:t>
            </a:r>
          </a:p>
          <a:p>
            <a:pPr algn="ctr"/>
            <a:r>
              <a:rPr lang="sv-SE" sz="2400" b="1" dirty="0" err="1"/>
              <a:t>control</a:t>
            </a:r>
            <a:endParaRPr lang="sv-SE" sz="2400" b="1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022F2F24-C1C4-D6F4-29C9-AE4D6D670684}"/>
              </a:ext>
            </a:extLst>
          </p:cNvPr>
          <p:cNvSpPr txBox="1"/>
          <p:nvPr/>
        </p:nvSpPr>
        <p:spPr>
          <a:xfrm>
            <a:off x="6391465" y="10819884"/>
            <a:ext cx="4413877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sv-SE" sz="2400" b="1" dirty="0" err="1"/>
              <a:t>Cytochalasin</a:t>
            </a:r>
            <a:r>
              <a:rPr lang="sv-SE" sz="2400" b="1" dirty="0"/>
              <a:t> D + C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20B01059-2E67-117D-C59A-D61A9C065F53}"/>
              </a:ext>
            </a:extLst>
          </p:cNvPr>
          <p:cNvSpPr txBox="1"/>
          <p:nvPr/>
        </p:nvSpPr>
        <p:spPr>
          <a:xfrm>
            <a:off x="10305010" y="10804362"/>
            <a:ext cx="4413877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sv-SE" sz="2400" b="1" dirty="0" err="1"/>
              <a:t>Wortmannin</a:t>
            </a:r>
            <a:r>
              <a:rPr lang="sv-SE" sz="2400" b="1" dirty="0"/>
              <a:t> + C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98FFC196-9D77-E93B-E403-17C34C3B6369}"/>
              </a:ext>
            </a:extLst>
          </p:cNvPr>
          <p:cNvSpPr txBox="1"/>
          <p:nvPr/>
        </p:nvSpPr>
        <p:spPr>
          <a:xfrm>
            <a:off x="464692" y="4940052"/>
            <a:ext cx="988937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sv-SE" sz="2400" b="1" dirty="0"/>
              <a:t>CC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DF2D280C-1611-962F-7F66-98E527032E9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1" r="207" b="15525"/>
          <a:stretch/>
        </p:blipFill>
        <p:spPr>
          <a:xfrm>
            <a:off x="8032720" y="735901"/>
            <a:ext cx="3223986" cy="3139890"/>
          </a:xfrm>
          <a:prstGeom prst="rect">
            <a:avLst/>
          </a:prstGeom>
        </p:spPr>
      </p:pic>
      <p:pic>
        <p:nvPicPr>
          <p:cNvPr id="7" name="Content Placeholder 4">
            <a:extLst>
              <a:ext uri="{FF2B5EF4-FFF2-40B4-BE49-F238E27FC236}">
                <a16:creationId xmlns:a16="http://schemas.microsoft.com/office/drawing/2014/main" xmlns="" id="{6DA2E95B-0E4B-9646-EABE-6AA6EB5807E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1907" b="15525"/>
          <a:stretch/>
        </p:blipFill>
        <p:spPr>
          <a:xfrm>
            <a:off x="1649606" y="723187"/>
            <a:ext cx="3194938" cy="3165556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xmlns="" id="{10BF57F0-1E58-C916-C403-2488B87403B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331" b="16326"/>
          <a:stretch/>
        </p:blipFill>
        <p:spPr>
          <a:xfrm>
            <a:off x="4831825" y="735901"/>
            <a:ext cx="3143370" cy="313989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xmlns="" id="{89D6BDC3-9C72-1332-DFE1-6A48F2B6932A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1753" b="14785"/>
          <a:stretch/>
        </p:blipFill>
        <p:spPr>
          <a:xfrm>
            <a:off x="1592460" y="4016087"/>
            <a:ext cx="3239365" cy="3232566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xmlns="" id="{DC66BDF0-FE2A-EF04-9EF2-BEFD3F7BDB2C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1" b="16375"/>
          <a:stretch/>
        </p:blipFill>
        <p:spPr>
          <a:xfrm>
            <a:off x="6662431" y="7700805"/>
            <a:ext cx="3491667" cy="3119079"/>
          </a:xfrm>
          <a:prstGeom prst="rect">
            <a:avLst/>
          </a:prstGeom>
        </p:spPr>
      </p:pic>
      <p:pic>
        <p:nvPicPr>
          <p:cNvPr id="2" name="Content Placeholder 6">
            <a:extLst>
              <a:ext uri="{FF2B5EF4-FFF2-40B4-BE49-F238E27FC236}">
                <a16:creationId xmlns:a16="http://schemas.microsoft.com/office/drawing/2014/main" xmlns="" id="{222901E4-0F91-17A1-DD4B-0A49B47913FE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b="15829"/>
          <a:stretch/>
        </p:blipFill>
        <p:spPr>
          <a:xfrm>
            <a:off x="11314230" y="735901"/>
            <a:ext cx="2997651" cy="3070863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C94D1076-A184-CA5F-2B65-C29C7E70F1D9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b="20554"/>
          <a:stretch/>
        </p:blipFill>
        <p:spPr>
          <a:xfrm>
            <a:off x="4930369" y="3982195"/>
            <a:ext cx="2976135" cy="334599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F52301FC-0CC0-77FC-97A1-BFF2F74DAB87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t="-578" b="15337"/>
          <a:stretch/>
        </p:blipFill>
        <p:spPr>
          <a:xfrm>
            <a:off x="7975195" y="3979221"/>
            <a:ext cx="3491667" cy="356981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xmlns="" id="{B180162B-EEB9-5027-4C3E-189479A02262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t="-1" b="20677"/>
          <a:stretch/>
        </p:blipFill>
        <p:spPr>
          <a:xfrm>
            <a:off x="11427315" y="3970344"/>
            <a:ext cx="3143368" cy="3369698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6C88A48C-CE41-4BF7-4A6B-161748C131E5}"/>
              </a:ext>
            </a:extLst>
          </p:cNvPr>
          <p:cNvSpPr txBox="1"/>
          <p:nvPr/>
        </p:nvSpPr>
        <p:spPr>
          <a:xfrm>
            <a:off x="12945603" y="7062092"/>
            <a:ext cx="4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400" b="1" dirty="0"/>
              <a:t>SS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7123729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C09EF6C3-82A8-F773-E7E6-7F6DE9C2D2E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5316"/>
          <a:stretch/>
        </p:blipFill>
        <p:spPr>
          <a:xfrm>
            <a:off x="8697596" y="352495"/>
            <a:ext cx="4609366" cy="437561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22FF8256-41EA-820D-78A9-57BC34243FD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5247" b="1287"/>
          <a:stretch/>
        </p:blipFill>
        <p:spPr>
          <a:xfrm>
            <a:off x="7161432" y="5219699"/>
            <a:ext cx="4645466" cy="437561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FAE215A5-924F-281F-732A-DBDBCDFDF15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5433" b="1155"/>
          <a:stretch/>
        </p:blipFill>
        <p:spPr>
          <a:xfrm>
            <a:off x="12783782" y="5286970"/>
            <a:ext cx="4708193" cy="4375613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395B030C-E913-BA62-FE7F-14886DFB4E98}"/>
              </a:ext>
            </a:extLst>
          </p:cNvPr>
          <p:cNvSpPr txBox="1"/>
          <p:nvPr/>
        </p:nvSpPr>
        <p:spPr>
          <a:xfrm>
            <a:off x="34560" y="1734710"/>
            <a:ext cx="344692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sv-SE" sz="2400" b="1" dirty="0" err="1"/>
              <a:t>Untreated</a:t>
            </a:r>
            <a:r>
              <a:rPr lang="sv-SE" sz="2400" b="1" dirty="0"/>
              <a:t> </a:t>
            </a:r>
            <a:r>
              <a:rPr lang="sv-SE" sz="2400" b="1" dirty="0" err="1"/>
              <a:t>control</a:t>
            </a:r>
            <a:endParaRPr lang="sv-SE" sz="24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98618FAA-9724-4628-D74E-E55E9988B45F}"/>
              </a:ext>
            </a:extLst>
          </p:cNvPr>
          <p:cNvSpPr txBox="1"/>
          <p:nvPr/>
        </p:nvSpPr>
        <p:spPr>
          <a:xfrm>
            <a:off x="7743626" y="9663058"/>
            <a:ext cx="4413877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sv-SE" sz="2400" b="1" dirty="0" err="1"/>
              <a:t>pHrodo</a:t>
            </a:r>
            <a:r>
              <a:rPr lang="sv-SE" sz="2400" b="1" dirty="0"/>
              <a:t> ™ Red </a:t>
            </a:r>
            <a:r>
              <a:rPr lang="sv-SE" sz="2400" b="1" i="1" dirty="0" err="1"/>
              <a:t>E.coli</a:t>
            </a:r>
            <a:r>
              <a:rPr lang="sv-SE" sz="2400" b="1" i="1" dirty="0"/>
              <a:t> </a:t>
            </a:r>
            <a:r>
              <a:rPr lang="sv-SE" sz="2400" b="1" dirty="0"/>
              <a:t>bioparticle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75830B96-5C38-CA33-DCA4-1F147AED7965}"/>
              </a:ext>
            </a:extLst>
          </p:cNvPr>
          <p:cNvSpPr txBox="1"/>
          <p:nvPr/>
        </p:nvSpPr>
        <p:spPr>
          <a:xfrm>
            <a:off x="13078098" y="9664317"/>
            <a:ext cx="4413877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sv-SE" sz="2400" b="1" dirty="0" err="1"/>
              <a:t>Cytochalasin</a:t>
            </a:r>
            <a:r>
              <a:rPr lang="sv-SE" sz="2400" b="1" dirty="0"/>
              <a:t> D + </a:t>
            </a:r>
            <a:r>
              <a:rPr lang="sv-SE" sz="2400" b="1" dirty="0" err="1"/>
              <a:t>pHrodo</a:t>
            </a:r>
            <a:r>
              <a:rPr lang="sv-SE" sz="2400" b="1" dirty="0"/>
              <a:t> ™ Red </a:t>
            </a:r>
            <a:r>
              <a:rPr lang="sv-SE" sz="2400" b="1" i="1" dirty="0" err="1"/>
              <a:t>E.coli</a:t>
            </a:r>
            <a:r>
              <a:rPr lang="sv-SE" sz="2400" b="1" i="1" dirty="0"/>
              <a:t> </a:t>
            </a:r>
            <a:r>
              <a:rPr lang="sv-SE" sz="2400" b="1" dirty="0"/>
              <a:t>bioparticle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243E964A-E7D3-F57E-9F17-C771D1C133F4}"/>
              </a:ext>
            </a:extLst>
          </p:cNvPr>
          <p:cNvSpPr txBox="1"/>
          <p:nvPr/>
        </p:nvSpPr>
        <p:spPr>
          <a:xfrm>
            <a:off x="1911297" y="10689581"/>
            <a:ext cx="1490183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3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low cytometry analysis of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Hrodo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™ Red  uptake in neutrophils. Cells were gated on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Hrodo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™ Red staining according to granularity on side scatter.</a:t>
            </a:r>
            <a:endParaRPr lang="sv-SE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xmlns="" id="{06884854-C5A5-D9E4-D8FB-C9C4B9ACAAE7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-1" r="776" b="26668"/>
          <a:stretch/>
        </p:blipFill>
        <p:spPr>
          <a:xfrm>
            <a:off x="4088230" y="168065"/>
            <a:ext cx="4609366" cy="4685012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259BC779-1EF0-8F0A-B1FB-BCFB4444A57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26886"/>
          <a:stretch/>
        </p:blipFill>
        <p:spPr>
          <a:xfrm>
            <a:off x="2106768" y="5043440"/>
            <a:ext cx="4910860" cy="46862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69387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66A11C64-D6CA-7789-7F69-43AC70FD7C1D}"/>
              </a:ext>
            </a:extLst>
          </p:cNvPr>
          <p:cNvSpPr txBox="1"/>
          <p:nvPr/>
        </p:nvSpPr>
        <p:spPr>
          <a:xfrm>
            <a:off x="14811297" y="8685287"/>
            <a:ext cx="3189366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sv-SE" sz="2400" b="1" dirty="0" err="1"/>
              <a:t>Cytochalasin</a:t>
            </a:r>
            <a:r>
              <a:rPr lang="sv-SE" sz="2400" b="1" dirty="0"/>
              <a:t> D + </a:t>
            </a:r>
          </a:p>
          <a:p>
            <a:pPr algn="ctr"/>
            <a:r>
              <a:rPr lang="sv-SE" sz="2400" b="1" dirty="0"/>
              <a:t>CC 0.5mg/ml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A03A5CEC-9E70-0101-9532-921BD0E2B0AD}"/>
              </a:ext>
            </a:extLst>
          </p:cNvPr>
          <p:cNvSpPr txBox="1"/>
          <p:nvPr/>
        </p:nvSpPr>
        <p:spPr>
          <a:xfrm>
            <a:off x="7883840" y="8869952"/>
            <a:ext cx="256203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sv-SE" sz="2400" b="1" dirty="0" err="1"/>
              <a:t>Untreated</a:t>
            </a:r>
            <a:r>
              <a:rPr lang="sv-SE" sz="2400" b="1" dirty="0"/>
              <a:t> </a:t>
            </a:r>
            <a:r>
              <a:rPr lang="sv-SE" sz="2400" b="1" dirty="0" err="1"/>
              <a:t>control</a:t>
            </a:r>
            <a:endParaRPr lang="sv-SE" sz="2400" b="1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6004990E-DAFB-5EEC-E87F-BC245A1925DE}"/>
              </a:ext>
            </a:extLst>
          </p:cNvPr>
          <p:cNvSpPr txBox="1"/>
          <p:nvPr/>
        </p:nvSpPr>
        <p:spPr>
          <a:xfrm>
            <a:off x="11569297" y="8869952"/>
            <a:ext cx="256203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sv-SE" sz="2400" b="1" dirty="0"/>
              <a:t>CC 0.5mg/ml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E81B43C3-23CC-8D0B-E85E-73E30BAD209C}"/>
              </a:ext>
            </a:extLst>
          </p:cNvPr>
          <p:cNvSpPr txBox="1"/>
          <p:nvPr/>
        </p:nvSpPr>
        <p:spPr>
          <a:xfrm>
            <a:off x="1075364" y="10604326"/>
            <a:ext cx="1617746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 smtClean="0">
                <a:latin typeface="Calibri" panose="020F0502020204030204" pitchFamily="34" charset="0"/>
                <a:ea typeface="Calibri" panose="020F0502020204030204" pitchFamily="34" charset="0"/>
              </a:rPr>
              <a:t>F</a:t>
            </a:r>
            <a:r>
              <a:rPr lang="en-US" sz="1800" b="1" dirty="0" smtClean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gure S4</a:t>
            </a: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: 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low cytometry analysis of CC uptake in neutrophils. Cells were gated on CD66b Bv421 positive staining according to granularity on side scatter.</a:t>
            </a:r>
            <a:endParaRPr lang="sv-SE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xmlns="" id="{87EF4CCB-5D72-D95C-DA62-38E56968F6A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3074"/>
          <a:stretch/>
        </p:blipFill>
        <p:spPr>
          <a:xfrm>
            <a:off x="3578280" y="1049304"/>
            <a:ext cx="3241620" cy="335921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F2EB051A-7752-843A-973D-263E7BCFA51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74163" y="1049304"/>
            <a:ext cx="3241620" cy="32705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EE302BEB-1BDE-F814-9BD5-114CA7CE059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53828" y="5406831"/>
            <a:ext cx="3472349" cy="348768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12E4C46C-D42C-42E8-5CB7-345E2C447BC5}"/>
              </a:ext>
            </a:extLst>
          </p:cNvPr>
          <p:cNvSpPr txBox="1"/>
          <p:nvPr/>
        </p:nvSpPr>
        <p:spPr>
          <a:xfrm rot="16200000">
            <a:off x="511075" y="6489177"/>
            <a:ext cx="2562033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4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D66b Bv421 positive staining</a:t>
            </a:r>
            <a:endParaRPr lang="sv-SE" sz="2400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0E6B4A1A-4ED0-C065-05A2-B035F0AFF1B7}"/>
              </a:ext>
            </a:extLst>
          </p:cNvPr>
          <p:cNvSpPr txBox="1"/>
          <p:nvPr/>
        </p:nvSpPr>
        <p:spPr>
          <a:xfrm rot="16200000">
            <a:off x="663475" y="2453721"/>
            <a:ext cx="256203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4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sotype control</a:t>
            </a:r>
            <a:endParaRPr lang="sv-SE" sz="2400" b="1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502B57D3-D094-23BF-CFB7-F17C5103CFE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16883"/>
          <a:stretch/>
        </p:blipFill>
        <p:spPr>
          <a:xfrm>
            <a:off x="7476849" y="5406832"/>
            <a:ext cx="3195934" cy="336964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xmlns="" id="{8760DD13-D16A-4109-7C71-97641A6DA09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804691" y="5406831"/>
            <a:ext cx="3472349" cy="336964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xmlns="" id="{5AB2FB6B-1DF9-5E0D-CE84-996852C74F3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4401679" y="5406832"/>
            <a:ext cx="3265693" cy="3369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662485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3460</TotalTime>
  <Words>171</Words>
  <Application>Microsoft Office PowerPoint</Application>
  <PresentationFormat>Custom</PresentationFormat>
  <Paragraphs>19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sha sujesh</dc:creator>
  <cp:lastModifiedBy>Rajalakshmi Thangaraj</cp:lastModifiedBy>
  <cp:revision>132</cp:revision>
  <cp:lastPrinted>2022-04-28T20:18:36Z</cp:lastPrinted>
  <dcterms:created xsi:type="dcterms:W3CDTF">2022-04-06T14:00:56Z</dcterms:created>
  <dcterms:modified xsi:type="dcterms:W3CDTF">2024-03-16T06:41:39Z</dcterms:modified>
</cp:coreProperties>
</file>